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456" r:id="rId2"/>
    <p:sldId id="451" r:id="rId3"/>
    <p:sldId id="452" r:id="rId4"/>
    <p:sldId id="454" r:id="rId5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FF00FF"/>
    <a:srgbClr val="CCCC00"/>
    <a:srgbClr val="FFFFCC"/>
    <a:srgbClr val="00B050"/>
    <a:srgbClr val="CCFFCC"/>
    <a:srgbClr val="800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720" autoAdjust="0"/>
    <p:restoredTop sz="97871" autoAdjust="0"/>
  </p:normalViewPr>
  <p:slideViewPr>
    <p:cSldViewPr snapToGrid="0" snapToObjects="1">
      <p:cViewPr>
        <p:scale>
          <a:sx n="200" d="100"/>
          <a:sy n="200" d="100"/>
        </p:scale>
        <p:origin x="996" y="373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2D7C38-EA57-4440-890E-B31CA2578E02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F9A969-D5AA-0445-A6EE-C42C6ADB19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328269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F6BF64-3A70-D348-9B85-F20692ED21CA}" type="datetimeFigureOut">
              <a:rPr lang="ja-JP" altLang="en-US" smtClean="0"/>
              <a:pPr/>
              <a:t>2018/1/19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E22EBB-5A77-6F46-9499-17612B322D7E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7723757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4D0F1-A422-944E-92F7-74EF7D17AD7E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00F39-FB1B-3A4D-BC85-AEB3EE5EFB22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FD8CC-EF2D-074A-809F-E73C114C91A8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1B7C3-385B-954F-BFE9-40C495BFE602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BA5E7-B1CF-9743-939B-465FB62CB396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402651-3DAA-2942-9964-EE58FF1C1633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A905-B6EB-8046-B54E-89CF219EE35D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85EBF-3FF8-7444-B6A5-D381D84EE227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FF0F41-2DE8-AC48-B8FE-C372B6E8D04A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0D2F-F16D-FC4B-8043-74257B0C6B77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F2D3F-DCC9-CB43-AA44-B724FF227633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EE311-E4ED-344C-8A5D-80F874CF0C53}" type="datetime1">
              <a:rPr lang="en-US" altLang="ja-JP" smtClean="0"/>
              <a:t>1/19/2018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64C92-6F46-E34F-9A37-96466B56D1BF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1</a:t>
            </a:fld>
            <a:endParaRPr lang="ja-JP" altLang="en-US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5619987"/>
              </p:ext>
            </p:extLst>
          </p:nvPr>
        </p:nvGraphicFramePr>
        <p:xfrm>
          <a:off x="482599" y="2700161"/>
          <a:ext cx="5706534" cy="326992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85334"/>
                <a:gridCol w="1329267"/>
                <a:gridCol w="1244600"/>
                <a:gridCol w="990600"/>
                <a:gridCol w="956733"/>
              </a:tblGrid>
              <a:tr h="355676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err="1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s</a:t>
                      </a: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mutant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err="1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Revertant</a:t>
                      </a:r>
                      <a:r>
                        <a:rPr lang="en-US" sz="1200" b="0" i="0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n</a:t>
                      </a: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umber in the mixture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ead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umber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Read length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Coverage/genome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871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0" i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cdc48-G338D</a:t>
                      </a:r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</a:t>
                      </a:r>
                      <a:endParaRPr lang="en-US" sz="1200" b="0" i="0" baseline="30000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6,493,064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9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871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5</a:t>
                      </a:r>
                      <a:endParaRPr lang="en-US" sz="1200" b="0" i="0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,089,148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871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b="0" i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eso1-G799D</a:t>
                      </a:r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4</a:t>
                      </a:r>
                      <a:endParaRPr lang="en-US" sz="1200" b="0" i="0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4,030,998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7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871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baseline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3</a:t>
                      </a:r>
                      <a:endParaRPr lang="en-US" sz="1200" b="0" i="0" dirty="0" smtClean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,361,462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447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3,324,316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0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447">
                <a:tc rowSpan="5">
                  <a:txBody>
                    <a:bodyPr/>
                    <a:lstStyle/>
                    <a:p>
                      <a:pPr algn="ctr"/>
                      <a:r>
                        <a:rPr lang="en-US" sz="1200" b="0" i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htb1-G52D</a:t>
                      </a:r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9,658,536</a:t>
                      </a:r>
                      <a:endParaRPr lang="cs-CZ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447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8,857,384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447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9,077,016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4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447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,716,068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03447">
                <a:tc vMerge="1">
                  <a:txBody>
                    <a:bodyPr/>
                    <a:lstStyle/>
                    <a:p>
                      <a:pPr algn="ctr"/>
                      <a:endParaRPr lang="en-US" sz="1200" b="0" i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27000" marR="27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5,552,480</a:t>
                      </a:r>
                      <a:endParaRPr lang="is-I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0b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0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4163369" y="20372"/>
            <a:ext cx="26946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"/>
                <a:cs typeface="Arial"/>
              </a:rPr>
              <a:t>Supplementary Tabl</a:t>
            </a:r>
            <a:r>
              <a:rPr lang="en-US" b="1" dirty="0" smtClean="0">
                <a:latin typeface="Arial"/>
                <a:cs typeface="Arial"/>
              </a:rPr>
              <a:t>e </a:t>
            </a:r>
            <a:r>
              <a:rPr lang="en-US" b="1" dirty="0">
                <a:latin typeface="Arial"/>
                <a:cs typeface="Arial"/>
              </a:rPr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4649" y="2435462"/>
            <a:ext cx="2980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Table S1</a:t>
            </a:r>
            <a:r>
              <a:rPr lang="en-US" sz="1200" dirty="0">
                <a:latin typeface="Arial"/>
                <a:cs typeface="Arial"/>
              </a:rPr>
              <a:t> </a:t>
            </a:r>
            <a:r>
              <a:rPr lang="en-US" sz="1200" dirty="0" smtClean="0">
                <a:latin typeface="Arial"/>
                <a:cs typeface="Arial"/>
              </a:rPr>
              <a:t>summary of sequencing </a:t>
            </a:r>
            <a:r>
              <a:rPr lang="en-US" sz="1200" dirty="0">
                <a:latin typeface="Arial"/>
                <a:cs typeface="Arial"/>
              </a:rPr>
              <a:t>results </a:t>
            </a:r>
          </a:p>
        </p:txBody>
      </p:sp>
    </p:spTree>
    <p:extLst>
      <p:ext uri="{BB962C8B-B14F-4D97-AF65-F5344CB8AC3E}">
        <p14:creationId xmlns:p14="http://schemas.microsoft.com/office/powerpoint/2010/main" val="2612541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2</a:t>
            </a:fld>
            <a:endParaRPr lang="ja-JP" altLang="en-US"/>
          </a:p>
        </p:txBody>
      </p:sp>
      <p:sp>
        <p:nvSpPr>
          <p:cNvPr id="5" name="TextBox 4"/>
          <p:cNvSpPr txBox="1"/>
          <p:nvPr/>
        </p:nvSpPr>
        <p:spPr>
          <a:xfrm>
            <a:off x="277161" y="771091"/>
            <a:ext cx="3830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Table S2 </a:t>
            </a:r>
            <a:r>
              <a:rPr lang="en-US" sz="1200" dirty="0" smtClean="0">
                <a:latin typeface="Arial"/>
                <a:cs typeface="Arial"/>
              </a:rPr>
              <a:t>Spontaneous suppressors of </a:t>
            </a:r>
            <a:r>
              <a:rPr lang="en-US" sz="1200" i="1" dirty="0" smtClean="0">
                <a:latin typeface="Arial"/>
                <a:cs typeface="Arial"/>
              </a:rPr>
              <a:t>cdc48-G338D</a:t>
            </a:r>
            <a:endParaRPr lang="en-US" sz="1200" i="1" dirty="0">
              <a:latin typeface="Arial"/>
              <a:cs typeface="Arial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310140"/>
              </p:ext>
            </p:extLst>
          </p:nvPr>
        </p:nvGraphicFramePr>
        <p:xfrm>
          <a:off x="376768" y="1041058"/>
          <a:ext cx="5964764" cy="63249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19890"/>
                <a:gridCol w="878024"/>
                <a:gridCol w="1139451"/>
                <a:gridCol w="829441"/>
                <a:gridCol w="2497958"/>
              </a:tblGrid>
              <a:tr h="426168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Gene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mino acid change</a:t>
                      </a: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utation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llele frequency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Gene product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40966">
                <a:tc>
                  <a:txBody>
                    <a:bodyPr/>
                    <a:lstStyle/>
                    <a:p>
                      <a:pPr algn="ctr" fontAlgn="b"/>
                      <a:r>
                        <a:rPr lang="nl-N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fd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99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28800:C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6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-protein ligase E4 (predicted)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40966">
                <a:tc>
                  <a:txBody>
                    <a:bodyPr/>
                    <a:lstStyle/>
                    <a:p>
                      <a:pPr algn="ctr" fontAlgn="b"/>
                      <a:r>
                        <a:rPr lang="nl-N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fd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ser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28822:T-&gt;T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.6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-protein ligase E4 (predicted)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40966">
                <a:tc>
                  <a:txBody>
                    <a:bodyPr/>
                    <a:lstStyle/>
                    <a:p>
                      <a:pPr algn="ctr" fontAlgn="b"/>
                      <a:r>
                        <a:rPr lang="nl-N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fd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297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29440:C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.5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-protein ligase E4 (predicted)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40966">
                <a:tc>
                  <a:txBody>
                    <a:bodyPr/>
                    <a:lstStyle/>
                    <a:p>
                      <a:pPr algn="ctr" fontAlgn="b"/>
                      <a:r>
                        <a:rPr lang="nl-N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fd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772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30864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4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-protein ligase E4 (predicted)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235R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198:A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1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267L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294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14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300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393:G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5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303K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401:G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7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369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600:G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.04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376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620:G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3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382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638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23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443S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822:T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.34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481L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7936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79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V517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8044:T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17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556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8160:T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4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556Y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8161:C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4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8975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587L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8254:G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9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84117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V619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8350:T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0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84117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649E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8441:T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.43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A family ATPase Cdc4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4163369" y="62707"/>
            <a:ext cx="26946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"/>
                <a:cs typeface="Arial"/>
              </a:rPr>
              <a:t>Supplementary Tabl</a:t>
            </a:r>
            <a:r>
              <a:rPr lang="en-US" b="1" dirty="0" smtClean="0">
                <a:latin typeface="Arial"/>
                <a:cs typeface="Arial"/>
              </a:rPr>
              <a:t>e </a:t>
            </a:r>
            <a:r>
              <a:rPr lang="en-US" b="1" dirty="0">
                <a:latin typeface="Arial"/>
                <a:cs typeface="Arial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1936035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3</a:t>
            </a:fld>
            <a:endParaRPr lang="ja-JP" altLang="en-US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1573731"/>
              </p:ext>
            </p:extLst>
          </p:nvPr>
        </p:nvGraphicFramePr>
        <p:xfrm>
          <a:off x="499526" y="2380484"/>
          <a:ext cx="5774270" cy="443941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86585"/>
                <a:gridCol w="830851"/>
                <a:gridCol w="1249567"/>
                <a:gridCol w="836245"/>
                <a:gridCol w="2271022"/>
              </a:tblGrid>
              <a:tr h="523139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Gene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mino acid change</a:t>
                      </a: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utation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llele frequency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Gene product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71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6309:A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95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166R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6024:T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4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169H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6015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1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174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6001:G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9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206D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904:G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5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215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878:G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.0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301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620:C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.2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302V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617:A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3.3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331R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529:A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.8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377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391:A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.9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393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344:A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63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587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4677:C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3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ele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6403:GC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.65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9734">
                <a:tc>
                  <a:txBody>
                    <a:bodyPr/>
                    <a:lstStyle/>
                    <a:p>
                      <a:pPr algn="ctr" fontAlgn="b"/>
                      <a:r>
                        <a:rPr lang="pl-PL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ser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5141:C-&gt;CT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.5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ings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nb-NO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part</a:t>
                      </a:r>
                      <a:r>
                        <a:rPr lang="nb-N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like homolog Wpl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97473" y="2109835"/>
            <a:ext cx="3710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Table </a:t>
            </a:r>
            <a:r>
              <a:rPr lang="en-US" sz="1200" b="1" dirty="0" smtClean="0">
                <a:latin typeface="Arial"/>
                <a:cs typeface="Arial"/>
              </a:rPr>
              <a:t>S3 </a:t>
            </a:r>
            <a:r>
              <a:rPr lang="en-US" sz="1200" dirty="0">
                <a:latin typeface="Arial"/>
                <a:cs typeface="Arial"/>
              </a:rPr>
              <a:t>Spontaneous suppressors of </a:t>
            </a:r>
            <a:r>
              <a:rPr lang="en-US" sz="1200" i="1" dirty="0" smtClean="0">
                <a:latin typeface="Arial"/>
                <a:cs typeface="Arial"/>
              </a:rPr>
              <a:t>eso1-G799D</a:t>
            </a:r>
            <a:endParaRPr lang="en-US" sz="1200" i="1" dirty="0">
              <a:latin typeface="Arial"/>
              <a:cs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163369" y="62707"/>
            <a:ext cx="26946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"/>
                <a:cs typeface="Arial"/>
              </a:rPr>
              <a:t>Supplementary Tabl</a:t>
            </a:r>
            <a:r>
              <a:rPr lang="en-US" b="1" dirty="0" smtClean="0">
                <a:latin typeface="Arial"/>
                <a:cs typeface="Arial"/>
              </a:rPr>
              <a:t>e </a:t>
            </a:r>
            <a:r>
              <a:rPr lang="en-US" b="1" dirty="0">
                <a:latin typeface="Arial"/>
                <a:cs typeface="Arial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8887380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64C92-6F46-E34F-9A37-96466B56D1BF}" type="slidenum">
              <a:rPr lang="ja-JP" altLang="en-US" smtClean="0"/>
              <a:pPr/>
              <a:t>4</a:t>
            </a:fld>
            <a:endParaRPr lang="ja-JP" altLang="en-US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1016432"/>
              </p:ext>
            </p:extLst>
          </p:nvPr>
        </p:nvGraphicFramePr>
        <p:xfrm>
          <a:off x="397935" y="929036"/>
          <a:ext cx="5998633" cy="731967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27474"/>
                <a:gridCol w="888766"/>
                <a:gridCol w="1074902"/>
                <a:gridCol w="770658"/>
                <a:gridCol w="2636833"/>
              </a:tblGrid>
              <a:tr h="413515"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Gene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mino acid change</a:t>
                      </a: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utation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llele frequency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Gene product</a:t>
                      </a:r>
                      <a:endParaRPr lang="en-US" sz="1200" b="0" i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1I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1388:C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2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Y86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0955:G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25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Y95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0929:T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.7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complex ubiquitin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196I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0625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9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232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0519:G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.9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282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0368:C-&gt;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.95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434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79770:C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5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8413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ser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0529:A-&gt;ACCACATAAAGATTTGCTGAGTT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.76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biquitin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C-terminal hydrolase Ubp8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cn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ser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974238:A-&gt;ACAAT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.31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complex histone acetyltransferase catalytic subunit Gcn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346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cn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ser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974738:C-&gt;CTCATTTAATGA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.0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complex histone acetyltransferase catalytic subunit Gcn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cn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ser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975155:C-&gt;C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.2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complex histone acetyltransferase catalytic subunit Gcn5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1116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fi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52E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79301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8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buni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Hfi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27874">
                <a:tc>
                  <a:txBody>
                    <a:bodyPr/>
                    <a:lstStyle/>
                    <a:p>
                      <a:pPr algn="ctr" fontAlgn="b"/>
                      <a:r>
                        <a:rPr lang="hu-H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gf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71874:A-&gt;AG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.2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buni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gf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1116">
                <a:tc>
                  <a:txBody>
                    <a:bodyPr/>
                    <a:lstStyle/>
                    <a:p>
                      <a:pPr algn="ctr" fontAlgn="b"/>
                      <a:r>
                        <a:rPr lang="hu-H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gf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64Stop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71882:G-&gt;A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.57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buni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gf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1116">
                <a:tc>
                  <a:txBody>
                    <a:bodyPr/>
                    <a:lstStyle/>
                    <a:p>
                      <a:pPr algn="ctr" fontAlgn="b"/>
                      <a:r>
                        <a:rPr lang="hu-H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gf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77Y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71842:C-&gt;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.50%</a:t>
                      </a:r>
                      <a:endParaRPr lang="en-US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buni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gf1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11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s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Y65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48203:T-&gt;C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.92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GA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omplex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bunit</a:t>
                      </a:r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us1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02683" y="664737"/>
            <a:ext cx="3633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Table </a:t>
            </a:r>
            <a:r>
              <a:rPr lang="en-US" sz="1200" b="1" dirty="0" smtClean="0">
                <a:latin typeface="Arial"/>
                <a:cs typeface="Arial"/>
              </a:rPr>
              <a:t>S4 </a:t>
            </a:r>
            <a:r>
              <a:rPr lang="en-US" sz="1200" dirty="0">
                <a:latin typeface="Arial"/>
                <a:cs typeface="Arial"/>
              </a:rPr>
              <a:t>Spontaneous suppressors of </a:t>
            </a:r>
            <a:r>
              <a:rPr lang="en-US" sz="1200" i="1" dirty="0" smtClean="0">
                <a:latin typeface="Arial"/>
                <a:cs typeface="Arial"/>
              </a:rPr>
              <a:t>htb1-G52D</a:t>
            </a:r>
            <a:endParaRPr lang="en-US" sz="1200" i="1" dirty="0">
              <a:latin typeface="Arial"/>
              <a:cs typeface="Arial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163369" y="20372"/>
            <a:ext cx="26981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"/>
                <a:cs typeface="Arial"/>
              </a:rPr>
              <a:t>Supplementary Tabl</a:t>
            </a:r>
            <a:r>
              <a:rPr lang="en-US" b="1" dirty="0" smtClean="0">
                <a:latin typeface="Arial"/>
                <a:cs typeface="Arial"/>
              </a:rPr>
              <a:t>e </a:t>
            </a:r>
            <a:r>
              <a:rPr lang="en-US" b="1" dirty="0">
                <a:latin typeface="Arial"/>
                <a:cs typeface="Arial"/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553961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627</TotalTime>
  <Words>694</Words>
  <Application>Microsoft Office PowerPoint</Application>
  <PresentationFormat>A4 Paper (210x297 mm)</PresentationFormat>
  <Paragraphs>32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Company>京都大学大学院生命科学研究科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中沢 宜彦</dc:creator>
  <cp:lastModifiedBy>Christine.Haller</cp:lastModifiedBy>
  <cp:revision>2421</cp:revision>
  <cp:lastPrinted>2016-02-04T02:54:54Z</cp:lastPrinted>
  <dcterms:created xsi:type="dcterms:W3CDTF">2013-07-17T00:36:15Z</dcterms:created>
  <dcterms:modified xsi:type="dcterms:W3CDTF">2018-01-19T14:50:23Z</dcterms:modified>
</cp:coreProperties>
</file>